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5" r:id="rId2"/>
    <p:sldId id="266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77" d="100"/>
          <a:sy n="77" d="100"/>
        </p:scale>
        <p:origin x="35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625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205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252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902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0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54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463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465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425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515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553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93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C8AF040-C401-4721-8166-EC6AEFBAE9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8" y="0"/>
            <a:ext cx="7107777" cy="1005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2700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B6E528-20F7-41C4-2F4F-E60ED7C8655A}"/>
              </a:ext>
            </a:extLst>
          </p:cNvPr>
          <p:cNvSpPr txBox="1"/>
          <p:nvPr/>
        </p:nvSpPr>
        <p:spPr>
          <a:xfrm>
            <a:off x="182880" y="465512"/>
            <a:ext cx="70325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able 2: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Effects of stroke and treatment with an IRAP inhibitor on inflammatory cytokine and chemokine gene expression at 24 h post stroke where treatment began at 6 h post stroke. The data was analysed using a two-way ANOVA followed by a Dunnett’s test (n=4).</a:t>
            </a:r>
            <a:r>
              <a:rPr lang="en-AU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2460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52</Words>
  <Application>Microsoft Macintosh PowerPoint</Application>
  <PresentationFormat>Custom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on Telianidis</dc:creator>
  <cp:lastModifiedBy>Jonathon Telianidis</cp:lastModifiedBy>
  <cp:revision>5</cp:revision>
  <dcterms:created xsi:type="dcterms:W3CDTF">2022-09-14T04:52:36Z</dcterms:created>
  <dcterms:modified xsi:type="dcterms:W3CDTF">2023-03-28T03:16:17Z</dcterms:modified>
</cp:coreProperties>
</file>